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0" d="100"/>
          <a:sy n="60" d="100"/>
        </p:scale>
        <p:origin x="-234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4513F-B83E-AB47-BE7E-4EC71C95E01B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0A911-9E8F-9A4F-8E77-04F8F7F54B3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42575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4513F-B83E-AB47-BE7E-4EC71C95E01B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0A911-9E8F-9A4F-8E77-04F8F7F54B3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4520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4513F-B83E-AB47-BE7E-4EC71C95E01B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0A911-9E8F-9A4F-8E77-04F8F7F54B3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81932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4513F-B83E-AB47-BE7E-4EC71C95E01B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0A911-9E8F-9A4F-8E77-04F8F7F54B3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39408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4513F-B83E-AB47-BE7E-4EC71C95E01B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0A911-9E8F-9A4F-8E77-04F8F7F54B3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58057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4513F-B83E-AB47-BE7E-4EC71C95E01B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0A911-9E8F-9A4F-8E77-04F8F7F54B3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10726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4513F-B83E-AB47-BE7E-4EC71C95E01B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0A911-9E8F-9A4F-8E77-04F8F7F54B3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16298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4513F-B83E-AB47-BE7E-4EC71C95E01B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0A911-9E8F-9A4F-8E77-04F8F7F54B3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51278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4513F-B83E-AB47-BE7E-4EC71C95E01B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0A911-9E8F-9A4F-8E77-04F8F7F54B3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64063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4513F-B83E-AB47-BE7E-4EC71C95E01B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0A911-9E8F-9A4F-8E77-04F8F7F54B3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97634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4513F-B83E-AB47-BE7E-4EC71C95E01B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60A911-9E8F-9A4F-8E77-04F8F7F54B3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31829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D4513F-B83E-AB47-BE7E-4EC71C95E01B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60A911-9E8F-9A4F-8E77-04F8F7F54B3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22930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0442994"/>
              </p:ext>
            </p:extLst>
          </p:nvPr>
        </p:nvGraphicFramePr>
        <p:xfrm>
          <a:off x="1314450" y="1801971"/>
          <a:ext cx="6515100" cy="1714500"/>
        </p:xfrm>
        <a:graphic>
          <a:graphicData uri="http://schemas.openxmlformats.org/drawingml/2006/table">
            <a:tbl>
              <a:tblPr/>
              <a:tblGrid>
                <a:gridCol w="469900"/>
                <a:gridCol w="1206500"/>
                <a:gridCol w="1193800"/>
                <a:gridCol w="1587500"/>
                <a:gridCol w="2057400"/>
              </a:tblGrid>
              <a:tr h="190500">
                <a:tc gridSpan="5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hr.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osition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 Name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 ID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T and AA Changes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972801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BP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_00113448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on10:c.A1535G:p.E512G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97284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BP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_00113448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on9:c.A1419G:p.I473M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tr-T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491269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KDD1B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_00127671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on2:c.C259G:p.L87V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174722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MEM30B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_00101797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on1:c.A637G:p.N213D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5441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CNA1H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_00100540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on10:c.C2410T:p.L804F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275440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FPL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M_00109853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on1:c.G348A:p.M116I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6950176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Macintosh PowerPoint</Application>
  <PresentationFormat>全屏显示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中南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ng Ma</dc:creator>
  <cp:lastModifiedBy>Long Ma</cp:lastModifiedBy>
  <cp:revision>1</cp:revision>
  <dcterms:created xsi:type="dcterms:W3CDTF">2018-06-04T06:25:20Z</dcterms:created>
  <dcterms:modified xsi:type="dcterms:W3CDTF">2018-06-04T06:25:38Z</dcterms:modified>
</cp:coreProperties>
</file>